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radley, Katharine" initials="BK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64" d="100"/>
          <a:sy n="64" d="100"/>
        </p:scale>
        <p:origin x="1660" y="4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commentAuthors" Target="comment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5F0A8-3569-4405-ADD3-666A738072CD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2899-AF9A-483B-B887-7F81D4183F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0185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5F0A8-3569-4405-ADD3-666A738072CD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2899-AF9A-483B-B887-7F81D4183F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183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5F0A8-3569-4405-ADD3-666A738072CD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2899-AF9A-483B-B887-7F81D4183F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5497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5F0A8-3569-4405-ADD3-666A738072CD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2899-AF9A-483B-B887-7F81D4183F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695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5F0A8-3569-4405-ADD3-666A738072CD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2899-AF9A-483B-B887-7F81D4183F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617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5F0A8-3569-4405-ADD3-666A738072CD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2899-AF9A-483B-B887-7F81D4183F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2428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5F0A8-3569-4405-ADD3-666A738072CD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2899-AF9A-483B-B887-7F81D4183F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37872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5F0A8-3569-4405-ADD3-666A738072CD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2899-AF9A-483B-B887-7F81D4183F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912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5F0A8-3569-4405-ADD3-666A738072CD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2899-AF9A-483B-B887-7F81D4183F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374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5F0A8-3569-4405-ADD3-666A738072CD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2899-AF9A-483B-B887-7F81D4183F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562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5F0A8-3569-4405-ADD3-666A738072CD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62899-AF9A-483B-B887-7F81D4183F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513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95F0A8-3569-4405-ADD3-666A738072CD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662899-AF9A-483B-B887-7F81D4183F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76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5087668" y="297850"/>
            <a:ext cx="1981200" cy="1615827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Operations Team</a:t>
            </a:r>
          </a:p>
          <a:p>
            <a:pPr algn="ctr"/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Weekly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mmunication &amp; oversight by NIDA C-CTN, DSC &amp; CCC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Updates from teams</a:t>
            </a:r>
          </a:p>
          <a:p>
            <a:pPr marL="454025" indent="-171450">
              <a:buFont typeface="Wingdings" panose="05000000000000000000" pitchFamily="2" charset="2"/>
              <a:buChar char="ü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dministrative</a:t>
            </a:r>
          </a:p>
          <a:p>
            <a:pPr marL="454025" indent="-171450">
              <a:buFont typeface="Wingdings" panose="05000000000000000000" pitchFamily="2" charset="2"/>
              <a:buChar char="ü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mplementation</a:t>
            </a:r>
          </a:p>
          <a:p>
            <a:pPr marL="454025" indent="-171450">
              <a:buFont typeface="Wingdings" panose="05000000000000000000" pitchFamily="2" charset="2"/>
              <a:buChar char="ü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ta &amp; Analytics</a:t>
            </a:r>
          </a:p>
          <a:p>
            <a:pPr marL="454025" indent="-171450">
              <a:buFont typeface="Wingdings" panose="05000000000000000000" pitchFamily="2" charset="2"/>
              <a:buChar char="ü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nvestigator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047998" y="602650"/>
            <a:ext cx="1753081" cy="13388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ead Node Meeting</a:t>
            </a:r>
          </a:p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Team Leaders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Weekly</a:t>
            </a:r>
          </a:p>
          <a:p>
            <a:pPr algn="ctr"/>
            <a:endParaRPr 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Updates from teams</a:t>
            </a:r>
          </a:p>
          <a:p>
            <a:pPr marL="454025" indent="-171450">
              <a:buFont typeface="Wingdings" panose="05000000000000000000" pitchFamily="2" charset="2"/>
              <a:buChar char="ü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dministrative</a:t>
            </a:r>
          </a:p>
          <a:p>
            <a:pPr marL="454025" indent="-171450">
              <a:buFont typeface="Wingdings" panose="05000000000000000000" pitchFamily="2" charset="2"/>
              <a:buChar char="ü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mplementation</a:t>
            </a:r>
          </a:p>
          <a:p>
            <a:pPr marL="454025" indent="-171450">
              <a:buFont typeface="Wingdings" panose="05000000000000000000" pitchFamily="2" charset="2"/>
              <a:buChar char="ü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ta &amp; Analytics</a:t>
            </a:r>
          </a:p>
          <a:p>
            <a:pPr marL="454025" indent="-171450">
              <a:buFont typeface="Wingdings" panose="05000000000000000000" pitchFamily="2" charset="2"/>
              <a:buChar char="ü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nvestigators</a:t>
            </a:r>
          </a:p>
        </p:txBody>
      </p:sp>
      <p:sp>
        <p:nvSpPr>
          <p:cNvPr id="15" name="Rectangle 14"/>
          <p:cNvSpPr/>
          <p:nvPr/>
        </p:nvSpPr>
        <p:spPr>
          <a:xfrm>
            <a:off x="2798534" y="396152"/>
            <a:ext cx="4578268" cy="1754915"/>
          </a:xfrm>
          <a:prstGeom prst="rect">
            <a:avLst/>
          </a:prstGeom>
          <a:noFill/>
          <a:ln w="539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548372" y="593948"/>
            <a:ext cx="1904998" cy="153965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>
              <a:lnSpc>
                <a:spcPct val="115000"/>
              </a:lnSpc>
            </a:pPr>
            <a:r>
              <a:rPr lang="en-US" sz="900" b="1" dirty="0">
                <a:effectLst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Lead Node </a:t>
            </a:r>
          </a:p>
          <a:p>
            <a:pPr algn="ctr">
              <a:lnSpc>
                <a:spcPct val="115000"/>
              </a:lnSpc>
            </a:pPr>
            <a:r>
              <a:rPr lang="en-US" sz="900" b="1" dirty="0">
                <a:effectLst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Administrative Team</a:t>
            </a:r>
          </a:p>
          <a:p>
            <a:pPr algn="ctr">
              <a:lnSpc>
                <a:spcPct val="115000"/>
              </a:lnSpc>
            </a:pPr>
            <a:r>
              <a:rPr lang="en-US" sz="900" i="1" dirty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Weekly</a:t>
            </a:r>
            <a:endParaRPr lang="en-US" sz="900" i="1" dirty="0">
              <a:effectLst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  <a:p>
            <a:pPr marL="171450" marR="0" lvl="0" indent="-57150">
              <a:buFont typeface="Arial" panose="020B0604020202020204" pitchFamily="34" charset="0"/>
              <a:buChar char="•"/>
            </a:pPr>
            <a:r>
              <a:rPr lang="en-US" sz="900" dirty="0">
                <a:effectLst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Contracts</a:t>
            </a:r>
            <a:endParaRPr lang="en-US" sz="900" dirty="0"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  <a:p>
            <a:pPr marL="171450" marR="0" lvl="0" indent="-57150">
              <a:buFont typeface="Arial" panose="020B0604020202020204" pitchFamily="34" charset="0"/>
              <a:buChar char="•"/>
            </a:pPr>
            <a:r>
              <a:rPr lang="en-US" sz="900" dirty="0">
                <a:effectLst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DUAs, DTAs</a:t>
            </a:r>
            <a:endParaRPr lang="en-US" sz="900" dirty="0"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  <a:p>
            <a:pPr marL="171450" marR="0" lvl="0" indent="-57150">
              <a:buFont typeface="Arial" panose="020B0604020202020204" pitchFamily="34" charset="0"/>
              <a:buChar char="•"/>
            </a:pPr>
            <a:r>
              <a:rPr lang="en-US" sz="900" dirty="0">
                <a:effectLst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Scheduling</a:t>
            </a:r>
            <a:endParaRPr lang="en-US" sz="900" dirty="0"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  <a:p>
            <a:pPr marL="171450" marR="0" lvl="0" indent="-57150">
              <a:buFont typeface="Arial" panose="020B0604020202020204" pitchFamily="34" charset="0"/>
              <a:buChar char="•"/>
            </a:pPr>
            <a:r>
              <a:rPr lang="en-US" sz="900" dirty="0">
                <a:effectLst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IRB </a:t>
            </a:r>
          </a:p>
          <a:p>
            <a:pPr marL="171450" marR="0" lvl="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Staffing meetings/action items</a:t>
            </a:r>
            <a:endParaRPr lang="en-US" sz="900" dirty="0">
              <a:effectLst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  <a:p>
            <a:pPr marL="171450" marR="0" lvl="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Regulatory with CCC</a:t>
            </a:r>
          </a:p>
          <a:p>
            <a:pPr marL="114300" marR="0" lvl="0"/>
            <a:endParaRPr lang="en-US" sz="900" dirty="0">
              <a:effectLst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grpSp>
        <p:nvGrpSpPr>
          <p:cNvPr id="72" name="Group 71"/>
          <p:cNvGrpSpPr/>
          <p:nvPr/>
        </p:nvGrpSpPr>
        <p:grpSpPr>
          <a:xfrm>
            <a:off x="436272" y="4798850"/>
            <a:ext cx="2078329" cy="1707548"/>
            <a:chOff x="714152" y="2498340"/>
            <a:chExt cx="1488690" cy="1826990"/>
          </a:xfrm>
        </p:grpSpPr>
        <p:sp>
          <p:nvSpPr>
            <p:cNvPr id="17" name="Rectangle 16"/>
            <p:cNvSpPr/>
            <p:nvPr/>
          </p:nvSpPr>
          <p:spPr>
            <a:xfrm>
              <a:off x="714152" y="2500212"/>
              <a:ext cx="1488690" cy="1825118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714152" y="2498340"/>
              <a:ext cx="1407567" cy="164735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115000"/>
                </a:lnSpc>
              </a:pPr>
              <a:endParaRPr lang="en-US" sz="900" b="1" dirty="0">
                <a:effectLst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  <a:p>
              <a:pPr algn="ctr">
                <a:lnSpc>
                  <a:spcPct val="115000"/>
                </a:lnSpc>
              </a:pPr>
              <a:r>
                <a:rPr lang="en-US" sz="900" b="1" dirty="0">
                  <a:effectLst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Technical</a:t>
              </a:r>
              <a:r>
                <a:rPr lang="en-US" sz="900" b="1" dirty="0"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 </a:t>
              </a:r>
              <a:r>
                <a:rPr lang="en-US" sz="900" b="1" dirty="0">
                  <a:effectLst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Assistance </a:t>
              </a:r>
            </a:p>
            <a:p>
              <a:pPr algn="ctr">
                <a:lnSpc>
                  <a:spcPct val="115000"/>
                </a:lnSpc>
              </a:pPr>
              <a:r>
                <a:rPr lang="en-US" sz="900" b="1" dirty="0">
                  <a:effectLst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Team </a:t>
              </a:r>
              <a:r>
                <a:rPr lang="en-US" sz="900" b="1" dirty="0"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at BMC</a:t>
              </a:r>
              <a:endParaRPr lang="en-US" sz="900" b="1" dirty="0">
                <a:effectLst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  <a:p>
              <a:pPr algn="ctr"/>
              <a:r>
                <a:rPr lang="en-US" sz="900" i="1" dirty="0"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Weekly</a:t>
              </a:r>
            </a:p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71450" lvl="0" indent="-57150">
                <a:buFont typeface="Arial" panose="020B0604020202020204" pitchFamily="34" charset="0"/>
                <a:buChar char="•"/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rovide PROUD Manual</a:t>
              </a:r>
            </a:p>
            <a:p>
              <a:pPr marL="171450" lvl="0" indent="-57150">
                <a:buFont typeface="Arial" panose="020B0604020202020204" pitchFamily="34" charset="0"/>
                <a:buChar char="•"/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CM hiring guidelines</a:t>
              </a:r>
            </a:p>
            <a:p>
              <a:pPr marL="171450" lvl="0" indent="-57150">
                <a:buFont typeface="Arial" panose="020B0604020202020204" pitchFamily="34" charset="0"/>
                <a:buChar char="•"/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CM Training</a:t>
              </a:r>
            </a:p>
            <a:p>
              <a:pPr marL="171450" lvl="0" indent="-57150">
                <a:buFont typeface="Arial" panose="020B0604020202020204" pitchFamily="34" charset="0"/>
                <a:buChar char="•"/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ntervention site visits (x2)</a:t>
              </a:r>
            </a:p>
            <a:p>
              <a:pPr marL="171450" lvl="0" indent="-57150">
                <a:buFont typeface="Arial" panose="020B0604020202020204" pitchFamily="34" charset="0"/>
                <a:buChar char="•"/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rovide TA to each NCM</a:t>
              </a:r>
              <a:endParaRPr lang="en-US" sz="9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2824629" y="5117180"/>
            <a:ext cx="1976450" cy="106182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Investigator Tea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Biweekly-Monthly</a:t>
            </a:r>
          </a:p>
          <a:p>
            <a:pPr algn="ctr"/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mplementation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arriers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eview Plan Papers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Write papers</a:t>
            </a:r>
          </a:p>
        </p:txBody>
      </p:sp>
      <p:sp>
        <p:nvSpPr>
          <p:cNvPr id="23" name="Rectangle 22"/>
          <p:cNvSpPr/>
          <p:nvPr/>
        </p:nvSpPr>
        <p:spPr>
          <a:xfrm>
            <a:off x="2732226" y="4800600"/>
            <a:ext cx="2215547" cy="17246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5325087" y="2477145"/>
            <a:ext cx="1990114" cy="2031325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Data &amp; Analytics Team:</a:t>
            </a:r>
          </a:p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Lead Node &amp; NIDA CTN DSC</a:t>
            </a:r>
          </a:p>
          <a:p>
            <a:pPr algn="ctr"/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Weekly</a:t>
            </a:r>
          </a:p>
          <a:p>
            <a:pPr algn="ctr"/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tatistical analysis plan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ta collection &amp; cleaning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llaboration with sites 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Quality checks 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ding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SMB reports (every 6 months)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aseline, main &amp; secondary analyses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e-identification of data for data sharing (as approved)</a:t>
            </a:r>
          </a:p>
        </p:txBody>
      </p:sp>
      <p:sp>
        <p:nvSpPr>
          <p:cNvPr id="29" name="Rectangle 28"/>
          <p:cNvSpPr/>
          <p:nvPr/>
        </p:nvSpPr>
        <p:spPr>
          <a:xfrm>
            <a:off x="5314723" y="2388395"/>
            <a:ext cx="2010840" cy="220882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/>
          <p:cNvSpPr txBox="1"/>
          <p:nvPr/>
        </p:nvSpPr>
        <p:spPr>
          <a:xfrm>
            <a:off x="5566231" y="5020015"/>
            <a:ext cx="1672769" cy="50783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Paper writing groups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hase 1 papers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hase 2 papers</a:t>
            </a:r>
          </a:p>
        </p:txBody>
      </p:sp>
      <p:sp>
        <p:nvSpPr>
          <p:cNvPr id="31" name="Rectangle 30"/>
          <p:cNvSpPr/>
          <p:nvPr/>
        </p:nvSpPr>
        <p:spPr>
          <a:xfrm>
            <a:off x="5304360" y="4998200"/>
            <a:ext cx="2010840" cy="5527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/>
          <p:cNvSpPr/>
          <p:nvPr/>
        </p:nvSpPr>
        <p:spPr>
          <a:xfrm>
            <a:off x="7574650" y="381000"/>
            <a:ext cx="1371600" cy="4347152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>
            <a:off x="7626266" y="559981"/>
            <a:ext cx="1371600" cy="3554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egend:</a:t>
            </a:r>
          </a:p>
          <a:p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MC: Boston Medical Center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CC: Clinical Coordinating Center 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-CTN: Center for Clinical Trials Network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TN: Clinical Trials Network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SC: Data and Statistics Center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UA: Data Use Agreement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TA: Data Transfer Agreement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RB: Institutional Review Board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CM: Nurse Care Manager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IDA: National Institute on Drug Abuse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A: Technical Assistance</a:t>
            </a:r>
          </a:p>
          <a:p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Straight Arrow Connector 43"/>
          <p:cNvCxnSpPr>
            <a:cxnSpLocks/>
            <a:stCxn id="89" idx="3"/>
          </p:cNvCxnSpPr>
          <p:nvPr/>
        </p:nvCxnSpPr>
        <p:spPr>
          <a:xfrm flipV="1">
            <a:off x="2511946" y="1359806"/>
            <a:ext cx="483571" cy="1799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>
            <a:endCxn id="31" idx="1"/>
          </p:cNvCxnSpPr>
          <p:nvPr/>
        </p:nvCxnSpPr>
        <p:spPr>
          <a:xfrm>
            <a:off x="4934581" y="5274570"/>
            <a:ext cx="369779" cy="0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Oval 32"/>
          <p:cNvSpPr/>
          <p:nvPr/>
        </p:nvSpPr>
        <p:spPr>
          <a:xfrm>
            <a:off x="2844306" y="2478068"/>
            <a:ext cx="2090275" cy="1950579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Rectangle 68"/>
          <p:cNvSpPr/>
          <p:nvPr/>
        </p:nvSpPr>
        <p:spPr>
          <a:xfrm>
            <a:off x="5325086" y="5764022"/>
            <a:ext cx="1990114" cy="767349"/>
          </a:xfrm>
          <a:prstGeom prst="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TextBox 69"/>
          <p:cNvSpPr txBox="1"/>
          <p:nvPr/>
        </p:nvSpPr>
        <p:spPr>
          <a:xfrm>
            <a:off x="5257801" y="5893780"/>
            <a:ext cx="2057400" cy="50783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ncillary Studies 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lvl="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conomics 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eath (planned)   </a:t>
            </a:r>
            <a:endParaRPr lang="en-US" sz="9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Straight Arrow Connector 33"/>
          <p:cNvCxnSpPr>
            <a:cxnSpLocks/>
          </p:cNvCxnSpPr>
          <p:nvPr/>
        </p:nvCxnSpPr>
        <p:spPr>
          <a:xfrm flipV="1">
            <a:off x="2514601" y="2003197"/>
            <a:ext cx="522020" cy="329701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>
            <a:endCxn id="31" idx="0"/>
          </p:cNvCxnSpPr>
          <p:nvPr/>
        </p:nvCxnSpPr>
        <p:spPr>
          <a:xfrm>
            <a:off x="6309780" y="4597220"/>
            <a:ext cx="0" cy="400980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3048001" y="2819400"/>
            <a:ext cx="1737779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ll Site Meetings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Weekly </a:t>
            </a:r>
          </a:p>
          <a:p>
            <a:pPr algn="ctr"/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(decreased over time)</a:t>
            </a:r>
          </a:p>
          <a:p>
            <a:pPr algn="ctr"/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mplementation 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dministrative </a:t>
            </a:r>
          </a:p>
          <a:p>
            <a:pPr marL="171450" indent="-571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ite updates</a:t>
            </a:r>
          </a:p>
          <a:p>
            <a:pPr algn="ctr"/>
            <a:endParaRPr lang="en-US" sz="9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Straight Arrow Connector 82"/>
          <p:cNvCxnSpPr>
            <a:endCxn id="39" idx="3"/>
          </p:cNvCxnSpPr>
          <p:nvPr/>
        </p:nvCxnSpPr>
        <p:spPr>
          <a:xfrm flipH="1">
            <a:off x="2514600" y="3467588"/>
            <a:ext cx="315720" cy="0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/>
          <p:cNvCxnSpPr/>
          <p:nvPr/>
        </p:nvCxnSpPr>
        <p:spPr>
          <a:xfrm flipH="1">
            <a:off x="4942193" y="3419452"/>
            <a:ext cx="354553" cy="0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Rectangle 88"/>
          <p:cNvSpPr/>
          <p:nvPr/>
        </p:nvSpPr>
        <p:spPr>
          <a:xfrm>
            <a:off x="436272" y="437209"/>
            <a:ext cx="2075674" cy="184879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2" name="Straight Arrow Connector 111"/>
          <p:cNvCxnSpPr>
            <a:cxnSpLocks/>
          </p:cNvCxnSpPr>
          <p:nvPr/>
        </p:nvCxnSpPr>
        <p:spPr>
          <a:xfrm>
            <a:off x="4801079" y="1966569"/>
            <a:ext cx="503281" cy="392464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/>
          <p:cNvCxnSpPr/>
          <p:nvPr/>
        </p:nvCxnSpPr>
        <p:spPr>
          <a:xfrm flipH="1">
            <a:off x="3902507" y="4435114"/>
            <a:ext cx="1" cy="337146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/>
          <p:cNvCxnSpPr>
            <a:cxnSpLocks/>
            <a:stCxn id="7" idx="2"/>
          </p:cNvCxnSpPr>
          <p:nvPr/>
        </p:nvCxnSpPr>
        <p:spPr>
          <a:xfrm flipH="1">
            <a:off x="3913161" y="1941478"/>
            <a:ext cx="11378" cy="514883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6" name="Group 35"/>
          <p:cNvGrpSpPr/>
          <p:nvPr/>
        </p:nvGrpSpPr>
        <p:grpSpPr>
          <a:xfrm>
            <a:off x="436272" y="2363175"/>
            <a:ext cx="2078328" cy="2208825"/>
            <a:chOff x="464560" y="2327727"/>
            <a:chExt cx="1529470" cy="1825118"/>
          </a:xfrm>
        </p:grpSpPr>
        <p:sp>
          <p:nvSpPr>
            <p:cNvPr id="39" name="Rectangle 38"/>
            <p:cNvSpPr/>
            <p:nvPr/>
          </p:nvSpPr>
          <p:spPr>
            <a:xfrm>
              <a:off x="464560" y="2327727"/>
              <a:ext cx="1529470" cy="1825118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503949" y="2478427"/>
              <a:ext cx="1484413" cy="144957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 b="1" dirty="0">
                  <a:effectLst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Lead Node</a:t>
              </a:r>
            </a:p>
            <a:p>
              <a:pPr algn="ctr"/>
              <a:r>
                <a:rPr lang="en-US" sz="900" b="1" dirty="0">
                  <a:effectLst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Im</a:t>
              </a:r>
              <a:r>
                <a:rPr lang="en-US" sz="900" b="1" dirty="0"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plementation</a:t>
              </a:r>
              <a:r>
                <a:rPr lang="en-US" sz="900" b="1" dirty="0">
                  <a:effectLst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 Monitoring Team</a:t>
              </a:r>
            </a:p>
            <a:p>
              <a:pPr lvl="0" algn="ctr"/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Weekly</a:t>
              </a:r>
            </a:p>
            <a:p>
              <a:pPr lvl="0"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71450" lvl="0" indent="-57150">
                <a:buFont typeface="Arial" panose="020B0604020202020204" pitchFamily="34" charset="0"/>
                <a:buChar char="•"/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onitor training</a:t>
              </a:r>
            </a:p>
            <a:p>
              <a:pPr marL="171450" lvl="0" indent="-57150">
                <a:buFont typeface="Arial" panose="020B0604020202020204" pitchFamily="34" charset="0"/>
                <a:buChar char="•"/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onitor weekly TA support</a:t>
              </a:r>
            </a:p>
            <a:p>
              <a:pPr marL="171450" lvl="0" indent="-57150">
                <a:buFont typeface="Arial" panose="020B0604020202020204" pitchFamily="34" charset="0"/>
                <a:buChar char="•"/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BMC Team debrief – Weekly</a:t>
              </a:r>
            </a:p>
            <a:p>
              <a:pPr marL="171450" lvl="0" indent="-57150">
                <a:buFont typeface="Arial" panose="020B0604020202020204" pitchFamily="34" charset="0"/>
                <a:buChar char="•"/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llect NCM reports - Weekly</a:t>
              </a:r>
            </a:p>
            <a:p>
              <a:pPr marL="171450" lvl="0" indent="-57150">
                <a:buFont typeface="Arial" panose="020B0604020202020204" pitchFamily="34" charset="0"/>
                <a:buChar char="•"/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Formative evaluation</a:t>
              </a:r>
            </a:p>
            <a:p>
              <a:pPr marL="171450" lvl="0" indent="-57150">
                <a:buFont typeface="Arial" panose="020B0604020202020204" pitchFamily="34" charset="0"/>
                <a:buChar char="•"/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ite PI debrief - Periodic</a:t>
              </a:r>
            </a:p>
            <a:p>
              <a:pPr marL="171450" indent="-57150">
                <a:buFont typeface="Arial" panose="020B0604020202020204" pitchFamily="34" charset="0"/>
                <a:buChar char="•"/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onitor/describe Usual Care</a:t>
              </a:r>
            </a:p>
            <a:p>
              <a:pPr marL="171450" indent="-57150">
                <a:buFont typeface="Arial" panose="020B0604020202020204" pitchFamily="34" charset="0"/>
                <a:buChar char="•"/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onitor/describe Exemplar</a:t>
              </a:r>
            </a:p>
          </p:txBody>
        </p:sp>
      </p:grpSp>
      <p:cxnSp>
        <p:nvCxnSpPr>
          <p:cNvPr id="41" name="Straight Arrow Connector 40"/>
          <p:cNvCxnSpPr>
            <a:cxnSpLocks/>
          </p:cNvCxnSpPr>
          <p:nvPr/>
        </p:nvCxnSpPr>
        <p:spPr>
          <a:xfrm>
            <a:off x="1418809" y="4546844"/>
            <a:ext cx="0" cy="253756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 flipV="1">
            <a:off x="4934581" y="4597220"/>
            <a:ext cx="390505" cy="203380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57F0EC29-BE81-447E-B71E-1F00ED46FD91}"/>
              </a:ext>
            </a:extLst>
          </p:cNvPr>
          <p:cNvSpPr txBox="1"/>
          <p:nvPr/>
        </p:nvSpPr>
        <p:spPr>
          <a:xfrm>
            <a:off x="2844306" y="66261"/>
            <a:ext cx="47140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ppendix 1. Organization of the PROUD Study Investigative Teams</a:t>
            </a:r>
          </a:p>
        </p:txBody>
      </p:sp>
    </p:spTree>
    <p:extLst>
      <p:ext uri="{BB962C8B-B14F-4D97-AF65-F5344CB8AC3E}">
        <p14:creationId xmlns:p14="http://schemas.microsoft.com/office/powerpoint/2010/main" val="37575482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6C4D4BCE7D9A445B6B94B9224C35682" ma:contentTypeVersion="11" ma:contentTypeDescription="Create a new document." ma:contentTypeScope="" ma:versionID="b0de76f54ad5ef653c4f2f804b6c3c99">
  <xsd:schema xmlns:xsd="http://www.w3.org/2001/XMLSchema" xmlns:xs="http://www.w3.org/2001/XMLSchema" xmlns:p="http://schemas.microsoft.com/office/2006/metadata/properties" xmlns:ns3="aae6e9b0-040e-407f-aef4-9a465eef00d6" xmlns:ns4="97fbfb1b-80ab-4f6d-90cf-0b9b58d3dbf0" targetNamespace="http://schemas.microsoft.com/office/2006/metadata/properties" ma:root="true" ma:fieldsID="1119104898ac9d603e2e1052046873eb" ns3:_="" ns4:_="">
    <xsd:import namespace="aae6e9b0-040e-407f-aef4-9a465eef00d6"/>
    <xsd:import namespace="97fbfb1b-80ab-4f6d-90cf-0b9b58d3dbf0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ae6e9b0-040e-407f-aef4-9a465eef00d6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7fbfb1b-80ab-4f6d-90cf-0b9b58d3dbf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12B4DFD2-B41B-474E-9E78-CED136BD9181}">
  <ds:schemaRefs>
    <ds:schemaRef ds:uri="http://www.w3.org/XML/1998/namespace"/>
    <ds:schemaRef ds:uri="http://purl.org/dc/terms/"/>
    <ds:schemaRef ds:uri="http://schemas.microsoft.com/office/2006/metadata/properties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97fbfb1b-80ab-4f6d-90cf-0b9b58d3dbf0"/>
    <ds:schemaRef ds:uri="aae6e9b0-040e-407f-aef4-9a465eef00d6"/>
    <ds:schemaRef ds:uri="http://purl.org/dc/dcmitype/"/>
    <ds:schemaRef ds:uri="http://purl.org/dc/elements/1.1/"/>
  </ds:schemaRefs>
</ds:datastoreItem>
</file>

<file path=customXml/itemProps2.xml><?xml version="1.0" encoding="utf-8"?>
<ds:datastoreItem xmlns:ds="http://schemas.openxmlformats.org/officeDocument/2006/customXml" ds:itemID="{D2504220-7406-4915-ACA5-A545F6C7662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87DD6EBF-4040-46F7-86B9-B2D4E0DC7AA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ae6e9b0-040e-407f-aef4-9a465eef00d6"/>
    <ds:schemaRef ds:uri="97fbfb1b-80ab-4f6d-90cf-0b9b58d3dbf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727</TotalTime>
  <Words>276</Words>
  <Application>Microsoft Office PowerPoint</Application>
  <PresentationFormat>On-screen Show (4:3)</PresentationFormat>
  <Paragraphs>9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Wingdings</vt:lpstr>
      <vt:lpstr>Office Theme</vt:lpstr>
      <vt:lpstr>PowerPoint Presentation</vt:lpstr>
    </vt:vector>
  </TitlesOfParts>
  <Company>GH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illips, Rebecca</dc:creator>
  <cp:lastModifiedBy>Cynthia Campbell</cp:lastModifiedBy>
  <cp:revision>100</cp:revision>
  <dcterms:created xsi:type="dcterms:W3CDTF">2017-04-27T16:52:13Z</dcterms:created>
  <dcterms:modified xsi:type="dcterms:W3CDTF">2021-01-10T23:05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6C4D4BCE7D9A445B6B94B9224C35682</vt:lpwstr>
  </property>
</Properties>
</file>